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59" r:id="rId1"/>
  </p:sldMasterIdLst>
  <p:notesMasterIdLst>
    <p:notesMasterId r:id="rId5"/>
  </p:notesMasterIdLst>
  <p:sldIdLst>
    <p:sldId id="266" r:id="rId2"/>
    <p:sldId id="267" r:id="rId3"/>
    <p:sldId id="272" r:id="rId4"/>
  </p:sldIdLst>
  <p:sldSz cx="6858000" cy="9144000" type="screen4x3"/>
  <p:notesSz cx="6858000" cy="9144000"/>
  <p:defaultTextStyle>
    <a:defPPr>
      <a:defRPr lang="es-CO" alt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5256" autoAdjust="0"/>
  </p:normalViewPr>
  <p:slideViewPr>
    <p:cSldViewPr>
      <p:cViewPr varScale="1">
        <p:scale>
          <a:sx n="88" d="100"/>
          <a:sy n="88" d="100"/>
        </p:scale>
        <p:origin x="-316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OCR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mmary Printout'!$AN$101</c:f>
              <c:strCache>
                <c:ptCount val="1"/>
                <c:pt idx="0">
                  <c:v>Cparvum-infected</c:v>
                </c:pt>
              </c:strCache>
            </c:strRef>
          </c:tx>
          <c:spPr>
            <a:ln w="15875">
              <a:solidFill>
                <a:srgbClr val="4A7EBB"/>
              </a:solidFill>
              <a:prstDash val="solid"/>
            </a:ln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solidFill>
                <a:srgbClr val="4A7EBB"/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R$102:$AR$113</c:f>
                <c:numCache>
                  <c:formatCode>General</c:formatCode>
                  <c:ptCount val="12"/>
                  <c:pt idx="0">
                    <c:v>21.106561482871353</c:v>
                  </c:pt>
                  <c:pt idx="1">
                    <c:v>19.5764037330948</c:v>
                  </c:pt>
                  <c:pt idx="2">
                    <c:v>19.017436465721293</c:v>
                  </c:pt>
                  <c:pt idx="3">
                    <c:v>16.02479034664081</c:v>
                  </c:pt>
                  <c:pt idx="4">
                    <c:v>16.010507208404071</c:v>
                  </c:pt>
                  <c:pt idx="5">
                    <c:v>16.260541829782127</c:v>
                  </c:pt>
                  <c:pt idx="6">
                    <c:v>6.8910051228477229</c:v>
                  </c:pt>
                  <c:pt idx="7">
                    <c:v>6.84858173367566</c:v>
                  </c:pt>
                  <c:pt idx="8">
                    <c:v>6.7980646169706125</c:v>
                  </c:pt>
                  <c:pt idx="9">
                    <c:v>6.5777370108822293</c:v>
                  </c:pt>
                  <c:pt idx="10">
                    <c:v>5.8017018653913901</c:v>
                  </c:pt>
                  <c:pt idx="11">
                    <c:v>5.8458936628028386</c:v>
                  </c:pt>
                </c:numCache>
              </c:numRef>
            </c:plus>
            <c:minus>
              <c:numRef>
                <c:f>'Summary Printout'!$AR$102:$AR$113</c:f>
                <c:numCache>
                  <c:formatCode>General</c:formatCode>
                  <c:ptCount val="12"/>
                  <c:pt idx="0">
                    <c:v>21.106561482871353</c:v>
                  </c:pt>
                  <c:pt idx="1">
                    <c:v>19.5764037330948</c:v>
                  </c:pt>
                  <c:pt idx="2">
                    <c:v>19.017436465721293</c:v>
                  </c:pt>
                  <c:pt idx="3">
                    <c:v>16.02479034664081</c:v>
                  </c:pt>
                  <c:pt idx="4">
                    <c:v>16.010507208404071</c:v>
                  </c:pt>
                  <c:pt idx="5">
                    <c:v>16.260541829782127</c:v>
                  </c:pt>
                  <c:pt idx="6">
                    <c:v>6.8910051228477229</c:v>
                  </c:pt>
                  <c:pt idx="7">
                    <c:v>6.84858173367566</c:v>
                  </c:pt>
                  <c:pt idx="8">
                    <c:v>6.7980646169706125</c:v>
                  </c:pt>
                  <c:pt idx="9">
                    <c:v>6.5777370108822293</c:v>
                  </c:pt>
                  <c:pt idx="10">
                    <c:v>5.8017018653913901</c:v>
                  </c:pt>
                  <c:pt idx="11">
                    <c:v>5.8458936628028386</c:v>
                  </c:pt>
                </c:numCache>
              </c:numRef>
            </c:minus>
          </c:errBars>
          <c:xVal>
            <c:numRef>
              <c:f>'Summary Printout'!$AM$102:$AM$113</c:f>
              <c:numCache>
                <c:formatCode>0.00</c:formatCode>
                <c:ptCount val="12"/>
                <c:pt idx="0">
                  <c:v>1.58915756166667</c:v>
                </c:pt>
                <c:pt idx="1">
                  <c:v>8.1926385633333307</c:v>
                </c:pt>
                <c:pt idx="2">
                  <c:v>14.7644811183333</c:v>
                </c:pt>
                <c:pt idx="3">
                  <c:v>21.4137046783333</c:v>
                </c:pt>
                <c:pt idx="4">
                  <c:v>27.982597065</c:v>
                </c:pt>
                <c:pt idx="5">
                  <c:v>34.592408458333303</c:v>
                </c:pt>
                <c:pt idx="6">
                  <c:v>41.286144621666701</c:v>
                </c:pt>
                <c:pt idx="7">
                  <c:v>47.855953726666698</c:v>
                </c:pt>
                <c:pt idx="8">
                  <c:v>54.463731670000001</c:v>
                </c:pt>
                <c:pt idx="9">
                  <c:v>61.1630947366667</c:v>
                </c:pt>
                <c:pt idx="10">
                  <c:v>67.779163096666693</c:v>
                </c:pt>
                <c:pt idx="11">
                  <c:v>74.402391923333298</c:v>
                </c:pt>
              </c:numCache>
            </c:numRef>
          </c:xVal>
          <c:yVal>
            <c:numRef>
              <c:f>'Summary Printout'!$AN$102:$AN$113</c:f>
              <c:numCache>
                <c:formatCode>0.0</c:formatCode>
                <c:ptCount val="12"/>
                <c:pt idx="0">
                  <c:v>88.204668000726357</c:v>
                </c:pt>
                <c:pt idx="1">
                  <c:v>84.916864287813667</c:v>
                </c:pt>
                <c:pt idx="2">
                  <c:v>83.639071632972332</c:v>
                </c:pt>
                <c:pt idx="3">
                  <c:v>69.179350123221468</c:v>
                </c:pt>
                <c:pt idx="4">
                  <c:v>68.87008687280273</c:v>
                </c:pt>
                <c:pt idx="5">
                  <c:v>68.811809305271964</c:v>
                </c:pt>
                <c:pt idx="6">
                  <c:v>27.692384622821365</c:v>
                </c:pt>
                <c:pt idx="7">
                  <c:v>28.638104600297737</c:v>
                </c:pt>
                <c:pt idx="8">
                  <c:v>29.524119023336468</c:v>
                </c:pt>
                <c:pt idx="9">
                  <c:v>30.621697782044567</c:v>
                </c:pt>
                <c:pt idx="10">
                  <c:v>29.140716097229198</c:v>
                </c:pt>
                <c:pt idx="11">
                  <c:v>28.38175478959966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3DC-455F-8F9C-231195148F92}"/>
            </c:ext>
          </c:extLst>
        </c:ser>
        <c:ser>
          <c:idx val="1"/>
          <c:order val="1"/>
          <c:tx>
            <c:strRef>
              <c:f>'Summary Printout'!$AO$101</c:f>
              <c:strCache>
                <c:ptCount val="1"/>
                <c:pt idx="0">
                  <c:v>non-infected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solidFill>
                <a:srgbClr val="BE4B48"/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S$102:$AS$113</c:f>
                <c:numCache>
                  <c:formatCode>General</c:formatCode>
                  <c:ptCount val="12"/>
                  <c:pt idx="0">
                    <c:v>4.9860510089693761</c:v>
                  </c:pt>
                  <c:pt idx="1">
                    <c:v>5.3488775895831324</c:v>
                  </c:pt>
                  <c:pt idx="2">
                    <c:v>5.2124503295911575</c:v>
                  </c:pt>
                  <c:pt idx="3">
                    <c:v>4.5618295869112178</c:v>
                  </c:pt>
                  <c:pt idx="4">
                    <c:v>4.0540444892315568</c:v>
                  </c:pt>
                  <c:pt idx="5">
                    <c:v>4.2109857802209705</c:v>
                  </c:pt>
                  <c:pt idx="6">
                    <c:v>2.1726529839660755</c:v>
                  </c:pt>
                  <c:pt idx="7">
                    <c:v>2.1504321615934954</c:v>
                  </c:pt>
                  <c:pt idx="8">
                    <c:v>2.0811943507567068</c:v>
                  </c:pt>
                  <c:pt idx="9">
                    <c:v>2.179815411083275</c:v>
                  </c:pt>
                  <c:pt idx="10">
                    <c:v>2.0287377945372813</c:v>
                  </c:pt>
                  <c:pt idx="11">
                    <c:v>1.9608329614175133</c:v>
                  </c:pt>
                </c:numCache>
              </c:numRef>
            </c:plus>
            <c:minus>
              <c:numRef>
                <c:f>'Summary Printout'!$AS$102:$AS$113</c:f>
                <c:numCache>
                  <c:formatCode>General</c:formatCode>
                  <c:ptCount val="12"/>
                  <c:pt idx="0">
                    <c:v>4.9860510089693761</c:v>
                  </c:pt>
                  <c:pt idx="1">
                    <c:v>5.3488775895831324</c:v>
                  </c:pt>
                  <c:pt idx="2">
                    <c:v>5.2124503295911575</c:v>
                  </c:pt>
                  <c:pt idx="3">
                    <c:v>4.5618295869112178</c:v>
                  </c:pt>
                  <c:pt idx="4">
                    <c:v>4.0540444892315568</c:v>
                  </c:pt>
                  <c:pt idx="5">
                    <c:v>4.2109857802209705</c:v>
                  </c:pt>
                  <c:pt idx="6">
                    <c:v>2.1726529839660755</c:v>
                  </c:pt>
                  <c:pt idx="7">
                    <c:v>2.1504321615934954</c:v>
                  </c:pt>
                  <c:pt idx="8">
                    <c:v>2.0811943507567068</c:v>
                  </c:pt>
                  <c:pt idx="9">
                    <c:v>2.179815411083275</c:v>
                  </c:pt>
                  <c:pt idx="10">
                    <c:v>2.0287377945372813</c:v>
                  </c:pt>
                  <c:pt idx="11">
                    <c:v>1.9608329614175133</c:v>
                  </c:pt>
                </c:numCache>
              </c:numRef>
            </c:minus>
          </c:errBars>
          <c:xVal>
            <c:numRef>
              <c:f>'Summary Printout'!$AM$102:$AM$113</c:f>
              <c:numCache>
                <c:formatCode>0.00</c:formatCode>
                <c:ptCount val="12"/>
                <c:pt idx="0">
                  <c:v>1.58915756166667</c:v>
                </c:pt>
                <c:pt idx="1">
                  <c:v>8.1926385633333307</c:v>
                </c:pt>
                <c:pt idx="2">
                  <c:v>14.7644811183333</c:v>
                </c:pt>
                <c:pt idx="3">
                  <c:v>21.4137046783333</c:v>
                </c:pt>
                <c:pt idx="4">
                  <c:v>27.982597065</c:v>
                </c:pt>
                <c:pt idx="5">
                  <c:v>34.592408458333303</c:v>
                </c:pt>
                <c:pt idx="6">
                  <c:v>41.286144621666701</c:v>
                </c:pt>
                <c:pt idx="7">
                  <c:v>47.855953726666698</c:v>
                </c:pt>
                <c:pt idx="8">
                  <c:v>54.463731670000001</c:v>
                </c:pt>
                <c:pt idx="9">
                  <c:v>61.1630947366667</c:v>
                </c:pt>
                <c:pt idx="10">
                  <c:v>67.779163096666693</c:v>
                </c:pt>
                <c:pt idx="11">
                  <c:v>74.402391923333298</c:v>
                </c:pt>
              </c:numCache>
            </c:numRef>
          </c:xVal>
          <c:yVal>
            <c:numRef>
              <c:f>'Summary Printout'!$AO$102:$AO$113</c:f>
              <c:numCache>
                <c:formatCode>0.0</c:formatCode>
                <c:ptCount val="12"/>
                <c:pt idx="0">
                  <c:v>55.797636526336866</c:v>
                </c:pt>
                <c:pt idx="1">
                  <c:v>53.097832143371704</c:v>
                </c:pt>
                <c:pt idx="2">
                  <c:v>52.194323596639798</c:v>
                </c:pt>
                <c:pt idx="3">
                  <c:v>44.975903396118497</c:v>
                </c:pt>
                <c:pt idx="4">
                  <c:v>44.798597764329863</c:v>
                </c:pt>
                <c:pt idx="5">
                  <c:v>44.715325045635602</c:v>
                </c:pt>
                <c:pt idx="6">
                  <c:v>19.337592371060701</c:v>
                </c:pt>
                <c:pt idx="7">
                  <c:v>19.436198929269466</c:v>
                </c:pt>
                <c:pt idx="8">
                  <c:v>19.4650943467845</c:v>
                </c:pt>
                <c:pt idx="9">
                  <c:v>19.216554731711231</c:v>
                </c:pt>
                <c:pt idx="10">
                  <c:v>18.419598490648131</c:v>
                </c:pt>
                <c:pt idx="11">
                  <c:v>18.22182439343503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3DC-455F-8F9C-231195148F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9454848"/>
        <c:axId val="259330048"/>
      </c:scatterChart>
      <c:valAx>
        <c:axId val="2594548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259330048"/>
        <c:crosses val="autoZero"/>
        <c:crossBetween val="midCat"/>
      </c:valAx>
      <c:valAx>
        <c:axId val="2593300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CR (pmol/min/Cells)</a:t>
                </a:r>
              </a:p>
            </c:rich>
          </c:tx>
          <c:layout/>
          <c:overlay val="0"/>
        </c:title>
        <c:numFmt formatCode="#0.0" sourceLinked="0"/>
        <c:majorTickMark val="out"/>
        <c:minorTickMark val="none"/>
        <c:tickLblPos val="nextTo"/>
        <c:crossAx val="259454848"/>
        <c:crosses val="autoZero"/>
        <c:crossBetween val="midCat"/>
      </c:valAx>
    </c:plotArea>
    <c:legend>
      <c:legendPos val="t"/>
      <c:layout/>
      <c:overlay val="0"/>
    </c:legend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100"/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numCol="1" rtlCol="0"/>
          <a:lstStyle>
            <a:lvl1pPr algn="l">
              <a:defRPr sz="1200"/>
            </a:lvl1pPr>
          </a:lstStyle>
          <a:p>
            <a:endParaRPr lang="de-DE" alt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numCol="1" rtlCol="0"/>
          <a:lstStyle>
            <a:lvl1pPr algn="r">
              <a:defRPr sz="1200"/>
            </a:lvl1pPr>
          </a:lstStyle>
          <a:p>
            <a:fld id="{9FEDF4E8-5EB5-47D8-B524-CBD76D09C95A}" type="datetimeFigureOut">
              <a:rPr lang="de-DE" altLang="de-DE" smtClean="0"/>
              <a:t>10.09.2021</a:t>
            </a:fld>
            <a:endParaRPr lang="de-DE" alt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numCol="1" rtlCol="0" anchor="ctr"/>
          <a:lstStyle/>
          <a:p>
            <a:endParaRPr lang="de-DE" alt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numCol="1" rtlCol="0"/>
          <a:lstStyle/>
          <a:p>
            <a:pPr lvl="0"/>
            <a:r>
              <a:rPr lang="de-DE" altLang="de-DE"/>
              <a:t>Formatvorlagen des Textmasters bearbeiten</a:t>
            </a:r>
          </a:p>
          <a:p>
            <a:pPr lvl="1"/>
            <a:r>
              <a:rPr lang="de-DE" altLang="de-DE"/>
              <a:t>Zweite Ebene</a:t>
            </a:r>
          </a:p>
          <a:p>
            <a:pPr lvl="2"/>
            <a:r>
              <a:rPr lang="de-DE" altLang="de-DE"/>
              <a:t>Dritte Ebene</a:t>
            </a:r>
          </a:p>
          <a:p>
            <a:pPr lvl="3"/>
            <a:r>
              <a:rPr lang="de-DE" altLang="de-DE"/>
              <a:t>Vierte Ebene</a:t>
            </a:r>
          </a:p>
          <a:p>
            <a:pPr lvl="4"/>
            <a:r>
              <a:rPr lang="de-DE" alt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numCol="1" rtlCol="0" anchor="b"/>
          <a:lstStyle>
            <a:lvl1pPr algn="l">
              <a:defRPr sz="1200"/>
            </a:lvl1pPr>
          </a:lstStyle>
          <a:p>
            <a:endParaRPr lang="de-DE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numCol="1" rtlCol="0" anchor="b"/>
          <a:lstStyle>
            <a:lvl1pPr algn="r">
              <a:defRPr sz="1200"/>
            </a:lvl1pPr>
          </a:lstStyle>
          <a:p>
            <a:fld id="{08B56CAF-3375-45B0-AC3A-BBED054FA895}" type="slidenum">
              <a:rPr lang="de-DE" altLang="de-DE" smtClean="0"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8451660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 numCol="1"/>
          <a:lstStyle/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 numCol="1"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altLang="es-ES"/>
              <a:t>Haga clic para modificar el estilo de subtítulo del patrón</a:t>
            </a:r>
            <a:endParaRPr lang="en-JM" altLang="en-JM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4096560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 numCol="1"/>
          <a:lstStyle/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 numCol="1"/>
          <a:lstStyle/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141471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 numCol="1"/>
          <a:lstStyle/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 numCol="1"/>
          <a:lstStyle/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4004133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 numCol="1"/>
          <a:lstStyle/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 numCol="1"/>
          <a:lstStyle/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3109108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numCol="1" anchor="t"/>
          <a:lstStyle>
            <a:lvl1pPr algn="l">
              <a:defRPr sz="4000" b="1" cap="all"/>
            </a:lvl1pPr>
          </a:lstStyle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numCol="1"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1768864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 numCol="1"/>
          <a:lstStyle/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 numCol="1"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 numCol="1"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81120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 numCol="1"/>
          <a:lstStyle>
            <a:lvl1pPr>
              <a:defRPr/>
            </a:lvl1pPr>
          </a:lstStyle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numCol="1"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 numCol="1"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numCol="1"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 numCol="1"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2629878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 numCol="1"/>
          <a:lstStyle/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2752913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2179280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numCol="1" anchor="b"/>
          <a:lstStyle>
            <a:lvl1pPr algn="l">
              <a:defRPr sz="2000" b="1"/>
            </a:lvl1pPr>
          </a:lstStyle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 numCol="1"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 numCol="1"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1700348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numCol="1" anchor="b"/>
          <a:lstStyle>
            <a:lvl1pPr algn="l">
              <a:defRPr sz="2000" b="1"/>
            </a:lvl1pPr>
          </a:lstStyle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numCol="1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M" altLang="en-JM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 numCol="1"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alt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 numCol="1"/>
          <a:lstStyle/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 numCol="1"/>
          <a:lstStyle/>
          <a:p>
            <a:endParaRPr lang="en-JM" altLang="en-JM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 numCol="1"/>
          <a:lstStyle/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865990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numCol="1" rtlCol="0" anchor="ctr">
            <a:normAutofit/>
          </a:bodyPr>
          <a:lstStyle/>
          <a:p>
            <a:r>
              <a:rPr lang="es-ES" altLang="es-ES"/>
              <a:t>Haga clic para modificar el estilo de título del patrón</a:t>
            </a:r>
            <a:endParaRPr lang="en-JM" altLang="en-JM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numCol="1" rtlCol="0">
            <a:normAutofit/>
          </a:bodyPr>
          <a:lstStyle/>
          <a:p>
            <a:pPr lvl="0"/>
            <a:r>
              <a:rPr lang="es-ES" altLang="es-ES"/>
              <a:t>Haga clic para modificar el estilo de texto del patrón</a:t>
            </a:r>
          </a:p>
          <a:p>
            <a:pPr lvl="1"/>
            <a:r>
              <a:rPr lang="es-ES" altLang="es-ES"/>
              <a:t>Segundo nivel</a:t>
            </a:r>
          </a:p>
          <a:p>
            <a:pPr lvl="2"/>
            <a:r>
              <a:rPr lang="es-ES" altLang="es-ES"/>
              <a:t>Tercer nivel</a:t>
            </a:r>
          </a:p>
          <a:p>
            <a:pPr lvl="3"/>
            <a:r>
              <a:rPr lang="es-ES" altLang="es-ES"/>
              <a:t>Cuarto nivel</a:t>
            </a:r>
          </a:p>
          <a:p>
            <a:pPr lvl="4"/>
            <a:r>
              <a:rPr lang="es-ES" altLang="es-ES"/>
              <a:t>Quinto nivel</a:t>
            </a:r>
            <a:endParaRPr lang="en-JM" altLang="en-JM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numCol="1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1C78AB-F408-46AB-A159-1345A78D976C}" type="datetimeFigureOut">
              <a:rPr lang="en-JM" altLang="en-JM" smtClean="0"/>
              <a:t>10/9/2021</a:t>
            </a:fld>
            <a:endParaRPr lang="en-JM" altLang="en-JM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numCol="1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M" altLang="en-JM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numCol="1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709B21-12D3-4C26-96CA-93138D5DE5E9}" type="slidenum">
              <a:rPr lang="en-JM" altLang="en-JM" smtClean="0"/>
              <a:t>‹Nr.›</a:t>
            </a:fld>
            <a:endParaRPr lang="en-JM" altLang="en-JM"/>
          </a:p>
        </p:txBody>
      </p:sp>
    </p:spTree>
    <p:extLst>
      <p:ext uri="{BB962C8B-B14F-4D97-AF65-F5344CB8AC3E}">
        <p14:creationId xmlns:p14="http://schemas.microsoft.com/office/powerpoint/2010/main" val="97148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 alt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f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2527" y="1938280"/>
            <a:ext cx="1764000" cy="176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2527" y="3760645"/>
            <a:ext cx="1764000" cy="1764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feld 21"/>
          <p:cNvSpPr txBox="1"/>
          <p:nvPr/>
        </p:nvSpPr>
        <p:spPr>
          <a:xfrm>
            <a:off x="0" y="5940152"/>
            <a:ext cx="6857999" cy="1323439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pPr algn="just"/>
            <a:r>
              <a:rPr lang="de-DE" altLang="de-DE" sz="1600" b="1" dirty="0">
                <a:latin typeface="Palatino Linotype" pitchFamily="18" charset="0"/>
                <a:cs typeface="Arial" panose="020B0604020202020204" pitchFamily="34" charset="0"/>
              </a:rPr>
              <a:t>S. 1.</a:t>
            </a:r>
            <a:r>
              <a:rPr lang="de-DE" altLang="de-DE" sz="1600" i="1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i="1" dirty="0" err="1">
                <a:latin typeface="Palatino Linotype" pitchFamily="18" charset="0"/>
                <a:cs typeface="Arial" panose="020B0604020202020204" pitchFamily="34" charset="0"/>
              </a:rPr>
              <a:t>Cryptopsoridium</a:t>
            </a:r>
            <a:r>
              <a:rPr lang="de-DE" altLang="de-DE" sz="1600" i="1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i="1" dirty="0" err="1">
                <a:latin typeface="Palatino Linotype" pitchFamily="18" charset="0"/>
                <a:cs typeface="Arial" panose="020B0604020202020204" pitchFamily="34" charset="0"/>
              </a:rPr>
              <a:t>parvum</a:t>
            </a:r>
            <a:r>
              <a:rPr lang="de-DE" altLang="de-DE" sz="1600" i="1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replication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upt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to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48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hpi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on Bovine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small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intestinal-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e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xplants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.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Infected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explants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were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kept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up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to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48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hpi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(a),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parasite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numbers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decreased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after 24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hpi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thought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. 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SEM-Analysis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revealed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developed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meronts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which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infected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the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>
                <a:latin typeface="Palatino Linotype" pitchFamily="18" charset="0"/>
                <a:cs typeface="Arial" panose="020B0604020202020204" pitchFamily="34" charset="0"/>
              </a:rPr>
              <a:t>villi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extensively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(b),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magnification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of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such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late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meront</a:t>
            </a:r>
            <a:r>
              <a:rPr lang="de-DE" altLang="de-DE" sz="1600" dirty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sz="1600" dirty="0" err="1" smtClean="0">
                <a:latin typeface="Palatino Linotype" pitchFamily="18" charset="0"/>
                <a:cs typeface="Arial" panose="020B0604020202020204" pitchFamily="34" charset="0"/>
              </a:rPr>
              <a:t>stages</a:t>
            </a:r>
            <a:r>
              <a:rPr lang="de-DE" altLang="de-DE" sz="1600" dirty="0" smtClean="0">
                <a:latin typeface="Palatino Linotype" pitchFamily="18" charset="0"/>
                <a:cs typeface="Arial" panose="020B0604020202020204" pitchFamily="34" charset="0"/>
              </a:rPr>
              <a:t>(b). </a:t>
            </a:r>
            <a:endParaRPr lang="de-DE" altLang="de-DE" sz="1600" dirty="0">
              <a:latin typeface="Palatino Linotype" pitchFamily="18" charset="0"/>
              <a:cs typeface="Arial" panose="020B0604020202020204" pitchFamily="34" charset="0"/>
            </a:endParaRPr>
          </a:p>
        </p:txBody>
      </p:sp>
      <p:pic>
        <p:nvPicPr>
          <p:cNvPr id="2051" name="Picture 3" descr="C:\Users\Juan\Google Drive\Doktorarbeit\Juan Doktorarbeit\Cryptosporidium\Reportes\Reportes\2020\IT 050620\replicaiton_it15052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33627" y="1938280"/>
            <a:ext cx="3861164" cy="360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feld 22"/>
          <p:cNvSpPr txBox="1"/>
          <p:nvPr/>
        </p:nvSpPr>
        <p:spPr>
          <a:xfrm>
            <a:off x="233627" y="5146397"/>
            <a:ext cx="281526" cy="400110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de-DE" altLang="de-DE" sz="2000" b="1" dirty="0" smtClean="0">
                <a:latin typeface="Palatino Linotype" pitchFamily="18" charset="0"/>
              </a:rPr>
              <a:t>a</a:t>
            </a:r>
            <a:endParaRPr lang="de-DE" altLang="de-DE" sz="2000" b="1" dirty="0">
              <a:latin typeface="Palatino Linotype" pitchFamily="18" charset="0"/>
            </a:endParaRPr>
          </a:p>
        </p:txBody>
      </p:sp>
      <p:sp>
        <p:nvSpPr>
          <p:cNvPr id="8" name="Textfeld 22"/>
          <p:cNvSpPr txBox="1"/>
          <p:nvPr/>
        </p:nvSpPr>
        <p:spPr>
          <a:xfrm>
            <a:off x="4206060" y="3298978"/>
            <a:ext cx="274366" cy="400110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de-DE" altLang="de-DE" sz="2000" b="1" dirty="0" smtClean="0">
                <a:latin typeface="Palatino Linotype" pitchFamily="18" charset="0"/>
              </a:rPr>
              <a:t>b</a:t>
            </a:r>
            <a:endParaRPr lang="de-DE" altLang="de-DE" sz="2000" b="1" dirty="0">
              <a:latin typeface="Palatino Linotype" pitchFamily="18" charset="0"/>
            </a:endParaRPr>
          </a:p>
        </p:txBody>
      </p:sp>
      <p:sp>
        <p:nvSpPr>
          <p:cNvPr id="22" name="Textfeld 22"/>
          <p:cNvSpPr txBox="1"/>
          <p:nvPr/>
        </p:nvSpPr>
        <p:spPr>
          <a:xfrm>
            <a:off x="4213574" y="5124535"/>
            <a:ext cx="533704" cy="400110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de-DE" altLang="de-DE" sz="2000" b="1" dirty="0" smtClean="0">
                <a:latin typeface="Palatino Linotype" pitchFamily="18" charset="0"/>
              </a:rPr>
              <a:t>c</a:t>
            </a:r>
            <a:endParaRPr lang="de-DE" altLang="de-DE" sz="2000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4337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8" name="Picture 10" descr="C:\Users\Juan\Google Drive\Doktorarbeit\Juan Doktorarbeit\Cryptosporidium\Publicaciones\2\3\IT 280819C\Glycolytic reserve_knetic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501007" y="1506116"/>
            <a:ext cx="3101973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feld 22"/>
          <p:cNvSpPr txBox="1"/>
          <p:nvPr/>
        </p:nvSpPr>
        <p:spPr>
          <a:xfrm>
            <a:off x="188640" y="3656784"/>
            <a:ext cx="281526" cy="369332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de-DE" altLang="de-DE" b="1" dirty="0" smtClean="0">
                <a:latin typeface="Palatino Linotype" panose="02040502050505030304" pitchFamily="18" charset="0"/>
              </a:rPr>
              <a:t>a</a:t>
            </a:r>
            <a:endParaRPr lang="de-DE" altLang="de-DE" b="1" dirty="0">
              <a:latin typeface="Palatino Linotype" panose="02040502050505030304" pitchFamily="18" charset="0"/>
            </a:endParaRPr>
          </a:p>
        </p:txBody>
      </p:sp>
      <p:sp>
        <p:nvSpPr>
          <p:cNvPr id="8" name="Textfeld 22"/>
          <p:cNvSpPr txBox="1"/>
          <p:nvPr/>
        </p:nvSpPr>
        <p:spPr>
          <a:xfrm>
            <a:off x="3626793" y="3656784"/>
            <a:ext cx="281526" cy="369332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de-DE" altLang="de-DE" b="1" dirty="0" smtClean="0">
                <a:latin typeface="Palatino Linotype" panose="02040502050505030304" pitchFamily="18" charset="0"/>
              </a:rPr>
              <a:t>b</a:t>
            </a:r>
            <a:endParaRPr lang="de-DE" altLang="de-DE" b="1" dirty="0">
              <a:latin typeface="Palatino Linotype" panose="02040502050505030304" pitchFamily="18" charset="0"/>
            </a:endParaRPr>
          </a:p>
        </p:txBody>
      </p:sp>
      <p:sp>
        <p:nvSpPr>
          <p:cNvPr id="9" name="Textfeld 22"/>
          <p:cNvSpPr txBox="1"/>
          <p:nvPr/>
        </p:nvSpPr>
        <p:spPr>
          <a:xfrm>
            <a:off x="188640" y="6650620"/>
            <a:ext cx="281526" cy="369332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de-DE" altLang="de-DE" b="1" dirty="0" smtClean="0">
                <a:latin typeface="Palatino Linotype" panose="02040502050505030304" pitchFamily="18" charset="0"/>
              </a:rPr>
              <a:t>c</a:t>
            </a:r>
            <a:endParaRPr lang="de-DE" altLang="de-DE" b="1" dirty="0">
              <a:latin typeface="Palatino Linotype" panose="02040502050505030304" pitchFamily="18" charset="0"/>
            </a:endParaRPr>
          </a:p>
        </p:txBody>
      </p:sp>
      <p:sp>
        <p:nvSpPr>
          <p:cNvPr id="13" name="Textfeld 21"/>
          <p:cNvSpPr txBox="1"/>
          <p:nvPr/>
        </p:nvSpPr>
        <p:spPr>
          <a:xfrm>
            <a:off x="1" y="7133788"/>
            <a:ext cx="6857999" cy="2031325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pPr algn="just"/>
            <a:r>
              <a:rPr lang="de-DE" altLang="de-DE" b="1" dirty="0">
                <a:latin typeface="Palatino Linotype" pitchFamily="18" charset="0"/>
                <a:cs typeface="Arial" panose="020B0604020202020204" pitchFamily="34" charset="0"/>
              </a:rPr>
              <a:t>S</a:t>
            </a:r>
            <a:r>
              <a:rPr lang="de-DE" altLang="de-DE" b="1" dirty="0" smtClean="0">
                <a:latin typeface="Palatino Linotype" pitchFamily="18" charset="0"/>
                <a:cs typeface="Arial" panose="020B0604020202020204" pitchFamily="34" charset="0"/>
              </a:rPr>
              <a:t>. 2.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seahorse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glycolysis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stress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test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of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i="1" dirty="0" smtClean="0">
                <a:latin typeface="Palatino Linotype" pitchFamily="18" charset="0"/>
                <a:cs typeface="Arial" panose="020B0604020202020204" pitchFamily="34" charset="0"/>
              </a:rPr>
              <a:t>C. </a:t>
            </a:r>
            <a:r>
              <a:rPr lang="de-DE" altLang="de-DE" i="1" dirty="0" err="1" smtClean="0">
                <a:latin typeface="Palatino Linotype" pitchFamily="18" charset="0"/>
                <a:cs typeface="Arial" panose="020B0604020202020204" pitchFamily="34" charset="0"/>
              </a:rPr>
              <a:t>parvum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-infected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BSIEC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revealed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parasite-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dependent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glycolytic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function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up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-regulation at 6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hpi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. </a:t>
            </a:r>
            <a:r>
              <a:rPr lang="en-US" altLang="de-DE" dirty="0" smtClean="0">
                <a:latin typeface="Palatino Linotype" pitchFamily="18" charset="0"/>
                <a:cs typeface="Arial" panose="020B0604020202020204" pitchFamily="34" charset="0"/>
              </a:rPr>
              <a:t>glycolytic capacity (a), glycolytic reserve (b) and non-glycolytic acidification (c) were </a:t>
            </a:r>
            <a:r>
              <a:rPr lang="en-US" altLang="de-DE" dirty="0" err="1" smtClean="0">
                <a:latin typeface="Palatino Linotype" pitchFamily="18" charset="0"/>
                <a:cs typeface="Arial" panose="020B0604020202020204" pitchFamily="34" charset="0"/>
              </a:rPr>
              <a:t>significaltively</a:t>
            </a:r>
            <a:r>
              <a:rPr lang="en-US" altLang="de-DE" dirty="0" smtClean="0">
                <a:latin typeface="Palatino Linotype" pitchFamily="18" charset="0"/>
                <a:cs typeface="Arial" panose="020B0604020202020204" pitchFamily="34" charset="0"/>
              </a:rPr>
              <a:t> higher at infected host-cells compared to non-infected and equally maintained controls</a:t>
            </a:r>
          </a:p>
          <a:p>
            <a:pPr algn="just"/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endParaRPr lang="de-DE" altLang="de-DE" dirty="0">
              <a:latin typeface="Palatino Linotype" pitchFamily="18" charset="0"/>
              <a:cs typeface="Arial" panose="020B0604020202020204" pitchFamily="34" charset="0"/>
            </a:endParaRPr>
          </a:p>
        </p:txBody>
      </p:sp>
      <p:pic>
        <p:nvPicPr>
          <p:cNvPr id="2055" name="Picture 7" descr="C:\Users\Juan\Google Drive\Doktorarbeit\Juan Doktorarbeit\Cryptosporidium\Publicaciones\2\3\IT 280819C\Glycolytic capacity_knetic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6844" y="1517300"/>
            <a:ext cx="3035031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C:\Users\Juan\Google Drive\Doktorarbeit\Juan Doktorarbeit\Cryptosporidium\Publicaciones\2\3\IT 280819C\non-glycolytic acidification_knetic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16632" y="4499952"/>
            <a:ext cx="3087753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708117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21"/>
          <p:cNvSpPr txBox="1"/>
          <p:nvPr/>
        </p:nvSpPr>
        <p:spPr>
          <a:xfrm>
            <a:off x="0" y="7740352"/>
            <a:ext cx="6857999" cy="646331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pPr algn="just"/>
            <a:r>
              <a:rPr lang="de-DE" altLang="de-DE" b="1" dirty="0">
                <a:latin typeface="Palatino Linotype" pitchFamily="18" charset="0"/>
                <a:cs typeface="Arial" panose="020B0604020202020204" pitchFamily="34" charset="0"/>
              </a:rPr>
              <a:t>S</a:t>
            </a:r>
            <a:r>
              <a:rPr lang="de-DE" altLang="de-DE" b="1" dirty="0" smtClean="0">
                <a:latin typeface="Palatino Linotype" pitchFamily="18" charset="0"/>
                <a:cs typeface="Arial" panose="020B0604020202020204" pitchFamily="34" charset="0"/>
              </a:rPr>
              <a:t>. 3. </a:t>
            </a:r>
            <a:r>
              <a:rPr lang="de-DE" altLang="de-DE" i="1" dirty="0">
                <a:latin typeface="Palatino Linotype" pitchFamily="18" charset="0"/>
                <a:cs typeface="Arial" panose="020B0604020202020204" pitchFamily="34" charset="0"/>
              </a:rPr>
              <a:t>C. </a:t>
            </a:r>
            <a:r>
              <a:rPr lang="de-DE" altLang="de-DE" i="1" dirty="0" err="1" smtClean="0">
                <a:latin typeface="Palatino Linotype" pitchFamily="18" charset="0"/>
                <a:cs typeface="Arial" panose="020B0604020202020204" pitchFamily="34" charset="0"/>
              </a:rPr>
              <a:t>parvum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-dependent</a:t>
            </a:r>
            <a:r>
              <a:rPr lang="de-DE" altLang="de-DE" i="1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upregulation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of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 ECAR </a:t>
            </a:r>
            <a:r>
              <a:rPr lang="de-DE" altLang="de-DE" dirty="0" err="1" smtClean="0">
                <a:latin typeface="Palatino Linotype" pitchFamily="18" charset="0"/>
                <a:cs typeface="Arial" panose="020B0604020202020204" pitchFamily="34" charset="0"/>
              </a:rPr>
              <a:t>and</a:t>
            </a:r>
            <a:r>
              <a:rPr lang="de-DE" altLang="de-DE" dirty="0" smtClean="0">
                <a:latin typeface="Palatino Linotype" pitchFamily="18" charset="0"/>
                <a:cs typeface="Arial" panose="020B0604020202020204" pitchFamily="34" charset="0"/>
              </a:rPr>
              <a:t> OCR on BSIEC 6 </a:t>
            </a:r>
            <a:r>
              <a:rPr lang="de-DE" altLang="de-DE" dirty="0" err="1">
                <a:latin typeface="Palatino Linotype" pitchFamily="18" charset="0"/>
                <a:cs typeface="Arial" panose="020B0604020202020204" pitchFamily="34" charset="0"/>
              </a:rPr>
              <a:t>hpi</a:t>
            </a:r>
            <a:r>
              <a:rPr lang="de-DE" altLang="de-DE" b="1" dirty="0" smtClean="0">
                <a:latin typeface="Palatino Linotype" pitchFamily="18" charset="0"/>
                <a:cs typeface="Arial" panose="020B0604020202020204" pitchFamily="34" charset="0"/>
              </a:rPr>
              <a:t> </a:t>
            </a:r>
            <a:endParaRPr lang="de-DE" altLang="de-DE" dirty="0">
              <a:latin typeface="Palatino Linotype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13" name="LittleChart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9277655"/>
              </p:ext>
            </p:extLst>
          </p:nvPr>
        </p:nvGraphicFramePr>
        <p:xfrm>
          <a:off x="404664" y="4361074"/>
          <a:ext cx="5846787" cy="29472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4" name="Gruppieren 13"/>
          <p:cNvGrpSpPr/>
          <p:nvPr/>
        </p:nvGrpSpPr>
        <p:grpSpPr>
          <a:xfrm>
            <a:off x="404665" y="539552"/>
            <a:ext cx="5846786" cy="3636104"/>
            <a:chOff x="1124744" y="1475656"/>
            <a:chExt cx="3927600" cy="2700000"/>
          </a:xfrm>
        </p:grpSpPr>
        <p:sp>
          <p:nvSpPr>
            <p:cNvPr id="7" name="Geschweifte Klammer rechts 6"/>
            <p:cNvSpPr/>
            <p:nvPr/>
          </p:nvSpPr>
          <p:spPr>
            <a:xfrm>
              <a:off x="3637432" y="2361013"/>
              <a:ext cx="219198" cy="526111"/>
            </a:xfrm>
            <a:prstGeom prst="rightBrace">
              <a:avLst/>
            </a:prstGeom>
            <a:solidFill>
              <a:srgbClr val="00B050"/>
            </a:solidFill>
            <a:ln w="9525" cap="flat" cmpd="sng" algn="ctr">
              <a:solidFill>
                <a:srgbClr val="00B050"/>
              </a:solidFill>
              <a:prstDash val="solid"/>
            </a:ln>
            <a:effectLst/>
          </p:spPr>
          <p:txBody>
            <a:bodyPr numCol="1" rtlCol="0" anchor="ctr"/>
            <a:lstStyle/>
            <a:p>
              <a:pPr algn="just">
                <a:lnSpc>
                  <a:spcPts val="1700"/>
                </a:lnSpc>
                <a:spcAft>
                  <a:spcPts val="0"/>
                </a:spcAft>
              </a:pPr>
              <a:r>
                <a:rPr lang="en-GB" altLang="en-GB" sz="1200">
                  <a:solidFill>
                    <a:srgbClr val="000000"/>
                  </a:solidFill>
                  <a:effectLst/>
                  <a:latin typeface="Times New Roman"/>
                  <a:ea typeface="Times New Roman"/>
                </a:rPr>
                <a:t> </a:t>
              </a:r>
              <a:endParaRPr lang="de-DE" altLang="de-DE" sz="1200">
                <a:solidFill>
                  <a:srgbClr val="000000"/>
                </a:solidFill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8" name="Rechteck 7"/>
            <p:cNvSpPr/>
            <p:nvPr/>
          </p:nvSpPr>
          <p:spPr>
            <a:xfrm>
              <a:off x="2932112" y="2360575"/>
              <a:ext cx="754077" cy="1269574"/>
            </a:xfrm>
            <a:prstGeom prst="rect">
              <a:avLst/>
            </a:prstGeom>
            <a:solidFill>
              <a:srgbClr val="9BBB59"/>
            </a:solidFill>
            <a:ln w="25400" cap="flat" cmpd="sng" algn="ctr">
              <a:solidFill>
                <a:srgbClr val="4F81BD">
                  <a:shade val="50000"/>
                  <a:alpha val="0"/>
                </a:srgbClr>
              </a:solidFill>
              <a:prstDash val="solid"/>
            </a:ln>
            <a:effectLst/>
          </p:spPr>
          <p:txBody>
            <a:bodyPr numCol="1" rtlCol="0" anchor="ctr"/>
            <a:lstStyle/>
            <a:p>
              <a:pPr algn="ctr">
                <a:spcAft>
                  <a:spcPts val="0"/>
                </a:spcAft>
              </a:pPr>
              <a:r>
                <a:rPr lang="en-GB" altLang="en-GB" sz="10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 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GB" altLang="en-GB" sz="10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 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GB" altLang="en-GB" sz="10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 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GB" altLang="en-GB" sz="9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Glycolytic capacity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9" name="Rechteck 8"/>
            <p:cNvSpPr/>
            <p:nvPr/>
          </p:nvSpPr>
          <p:spPr>
            <a:xfrm>
              <a:off x="2176112" y="2887124"/>
              <a:ext cx="756000" cy="796581"/>
            </a:xfrm>
            <a:prstGeom prst="rect">
              <a:avLst/>
            </a:prstGeom>
            <a:solidFill>
              <a:srgbClr val="4F81BD"/>
            </a:solidFill>
            <a:ln w="25400" cap="flat" cmpd="sng" algn="ctr">
              <a:solidFill>
                <a:srgbClr val="4F81BD">
                  <a:shade val="50000"/>
                  <a:alpha val="0"/>
                </a:srgbClr>
              </a:solidFill>
              <a:prstDash val="solid"/>
            </a:ln>
            <a:effectLst/>
          </p:spPr>
          <p:txBody>
            <a:bodyPr numCol="1" rtlCol="0" anchor="ctr"/>
            <a:lstStyle/>
            <a:p>
              <a:pPr algn="ctr">
                <a:spcAft>
                  <a:spcPts val="0"/>
                </a:spcAft>
              </a:pPr>
              <a:r>
                <a:rPr lang="en-GB" altLang="en-GB" sz="10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 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GB" altLang="en-GB" sz="10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 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GB" altLang="en-GB" sz="9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Glycolysis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0" name="Rechteck 9"/>
            <p:cNvSpPr/>
            <p:nvPr/>
          </p:nvSpPr>
          <p:spPr>
            <a:xfrm>
              <a:off x="1639818" y="3583427"/>
              <a:ext cx="2772000" cy="109679"/>
            </a:xfrm>
            <a:prstGeom prst="rect">
              <a:avLst/>
            </a:prstGeom>
            <a:solidFill>
              <a:srgbClr val="C0504D"/>
            </a:solidFill>
            <a:ln w="25400" cap="flat" cmpd="sng" algn="ctr">
              <a:solidFill>
                <a:srgbClr val="4F81BD">
                  <a:shade val="50000"/>
                  <a:alpha val="0"/>
                </a:srgbClr>
              </a:solidFill>
              <a:prstDash val="solid"/>
            </a:ln>
            <a:effectLst/>
          </p:spPr>
          <p:txBody>
            <a:bodyPr numCol="1" rtlCol="0" anchor="ctr"/>
            <a:lstStyle/>
            <a:p>
              <a:pPr algn="ctr">
                <a:spcAft>
                  <a:spcPts val="0"/>
                </a:spcAft>
              </a:pPr>
              <a:r>
                <a:rPr lang="en-GB" altLang="en-GB" sz="12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Non-glycolytic acidification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1" name="Textfeld 58"/>
            <p:cNvSpPr txBox="1"/>
            <p:nvPr/>
          </p:nvSpPr>
          <p:spPr>
            <a:xfrm>
              <a:off x="3839547" y="2356101"/>
              <a:ext cx="699044" cy="369332"/>
            </a:xfrm>
            <a:prstGeom prst="rect">
              <a:avLst/>
            </a:prstGeom>
            <a:noFill/>
          </p:spPr>
          <p:txBody>
            <a:bodyPr wrap="square" numCol="1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altLang="en-GB" sz="9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Glycolytic reserve</a:t>
              </a:r>
              <a:endParaRPr lang="de-DE" altLang="de-DE" sz="1200" dirty="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12" name="Picture 7" descr="C:\Users\Juan\Google Drive\Doktorarbeit\Juan Doktorarbeit\Cryptosporidium\Publicaciones\2\3\IT 280819C\OVERVIEW.tif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124744" y="1475656"/>
              <a:ext cx="3927600" cy="270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9308417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1</Words>
  <Application>Microsoft Office PowerPoint</Application>
  <PresentationFormat>Bildschirmpräsentation (4:3)</PresentationFormat>
  <Paragraphs>23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Tema de 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</dc:creator>
  <cp:lastModifiedBy>Juan</cp:lastModifiedBy>
  <cp:revision>201</cp:revision>
  <dcterms:created xsi:type="dcterms:W3CDTF">2020-04-17T11:40:43Z</dcterms:created>
  <dcterms:modified xsi:type="dcterms:W3CDTF">2021-09-10T09:15:39Z</dcterms:modified>
</cp:coreProperties>
</file>